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30" r:id="rId1"/>
  </p:sldMasterIdLst>
  <p:notesMasterIdLst>
    <p:notesMasterId r:id="rId3"/>
  </p:notesMasterIdLst>
  <p:sldIdLst>
    <p:sldId id="718" r:id="rId2"/>
  </p:sldIdLst>
  <p:sldSz cx="6858000" cy="9906000" type="A4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E958A"/>
    <a:srgbClr val="F3DA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6324" autoAdjust="0"/>
    <p:restoredTop sz="89748" autoAdjust="0"/>
  </p:normalViewPr>
  <p:slideViewPr>
    <p:cSldViewPr>
      <p:cViewPr>
        <p:scale>
          <a:sx n="66" d="100"/>
          <a:sy n="66" d="100"/>
        </p:scale>
        <p:origin x="-2604" y="16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-shindo\Documents\H22&#30149;&#29702;\D2-40\&#32080;&#26524;\RT-PCR\after%20MACS\&#35542;&#25991;&#29992;glaph%20and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en-US" dirty="0" smtClean="0"/>
              <a:t>PDPN/18</a:t>
            </a:r>
            <a:r>
              <a:rPr lang="en-US" altLang="ja-JP" dirty="0" smtClean="0"/>
              <a:t>S</a:t>
            </a:r>
            <a:endParaRPr lang="en-US" alt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31</c:f>
              <c:strCache>
                <c:ptCount val="1"/>
                <c:pt idx="0">
                  <c:v>PDPN/18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32:$C$37</c:f>
                <c:numCache>
                  <c:formatCode>General</c:formatCode>
                  <c:ptCount val="6"/>
                  <c:pt idx="0">
                    <c:v>4.9516769116148543E-3</c:v>
                  </c:pt>
                  <c:pt idx="1">
                    <c:v>2.1256151362402059E-4</c:v>
                  </c:pt>
                  <c:pt idx="2">
                    <c:v>4.3551530281221357E-2</c:v>
                  </c:pt>
                  <c:pt idx="3">
                    <c:v>2.2760436004525201E-4</c:v>
                  </c:pt>
                  <c:pt idx="4">
                    <c:v>3.7351106923422847E-2</c:v>
                  </c:pt>
                  <c:pt idx="5">
                    <c:v>3.1082827825705175E-3</c:v>
                  </c:pt>
                </c:numCache>
              </c:numRef>
            </c:plus>
            <c:minus>
              <c:numRef>
                <c:f>Sheet1!$C$32:$C$37</c:f>
                <c:numCache>
                  <c:formatCode>General</c:formatCode>
                  <c:ptCount val="6"/>
                  <c:pt idx="0">
                    <c:v>4.9516769116148543E-3</c:v>
                  </c:pt>
                  <c:pt idx="1">
                    <c:v>2.1256151362402059E-4</c:v>
                  </c:pt>
                  <c:pt idx="2">
                    <c:v>4.3551530281221357E-2</c:v>
                  </c:pt>
                  <c:pt idx="3">
                    <c:v>2.2760436004525201E-4</c:v>
                  </c:pt>
                  <c:pt idx="4">
                    <c:v>3.7351106923422847E-2</c:v>
                  </c:pt>
                  <c:pt idx="5">
                    <c:v>3.1082827825705175E-3</c:v>
                  </c:pt>
                </c:numCache>
              </c:numRef>
            </c:minus>
          </c:errBars>
          <c:cat>
            <c:strRef>
              <c:f>Sheet1!$A$32:$A$37</c:f>
              <c:strCache>
                <c:ptCount val="6"/>
                <c:pt idx="0">
                  <c:v>CAF1</c:v>
                </c:pt>
                <c:pt idx="1">
                  <c:v>CAF2</c:v>
                </c:pt>
                <c:pt idx="2">
                  <c:v>CAF3 +</c:v>
                </c:pt>
                <c:pt idx="3">
                  <c:v>CAF3 -</c:v>
                </c:pt>
                <c:pt idx="4">
                  <c:v>CAF4 +</c:v>
                </c:pt>
                <c:pt idx="5">
                  <c:v>CAF4 -</c:v>
                </c:pt>
              </c:strCache>
            </c:strRef>
          </c:cat>
          <c:val>
            <c:numRef>
              <c:f>Sheet1!$B$32:$B$37</c:f>
              <c:numCache>
                <c:formatCode>General</c:formatCode>
                <c:ptCount val="6"/>
                <c:pt idx="0">
                  <c:v>0.26151828448975828</c:v>
                </c:pt>
                <c:pt idx="1">
                  <c:v>1.272541379952738E-3</c:v>
                </c:pt>
                <c:pt idx="2">
                  <c:v>0.13316597214760459</c:v>
                </c:pt>
                <c:pt idx="3">
                  <c:v>1.381762947086013E-2</c:v>
                </c:pt>
                <c:pt idx="4">
                  <c:v>0.25882352941176501</c:v>
                </c:pt>
                <c:pt idx="5">
                  <c:v>7.8518518518517991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272960"/>
        <c:axId val="74958528"/>
      </c:barChart>
      <c:catAx>
        <c:axId val="3927296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600" b="1"/>
            </a:pPr>
            <a:endParaRPr lang="ja-JP"/>
          </a:p>
        </c:txPr>
        <c:crossAx val="74958528"/>
        <c:crosses val="autoZero"/>
        <c:auto val="1"/>
        <c:lblAlgn val="ctr"/>
        <c:lblOffset val="100"/>
        <c:noMultiLvlLbl val="0"/>
      </c:catAx>
      <c:valAx>
        <c:axId val="7495852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ja-JP"/>
          </a:p>
        </c:txPr>
        <c:crossAx val="39272960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56554347-2F58-4697-854A-F960760ABE0C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4CFB7241-8E82-4B92-B050-CC07426070A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6133126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78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ln/>
        </p:spPr>
      </p:sp>
      <p:sp>
        <p:nvSpPr>
          <p:cNvPr id="50179" name="ノート プレースホルダ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i="0" dirty="0" smtClean="0"/>
          </a:p>
        </p:txBody>
      </p:sp>
      <p:sp>
        <p:nvSpPr>
          <p:cNvPr id="50180" name="スライド番号プレースホルダ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9pPr>
          </a:lstStyle>
          <a:p>
            <a:pPr eaLnBrk="1" hangingPunct="1"/>
            <a:fld id="{55011C53-D8D9-492F-BEAE-8852693C4A34}" type="slidenum">
              <a:rPr lang="ja-JP" altLang="en-US" sz="1200" smtClean="0"/>
              <a:pPr eaLnBrk="1" hangingPunct="1"/>
              <a:t>1</a:t>
            </a:fld>
            <a:endParaRPr lang="en-US" altLang="ja-JP" sz="1200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354CD9-580E-461A-80CF-44FB1D919C69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531A76-71E6-41B8-8DC6-FDF10B7A223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B738AF-CE38-48C4-A41D-38E704272DD6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459600-453C-4F1C-A85C-DA3B76FD6BB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F19CBD-9A2B-4F30-A05F-CD15B4B89468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2D0233-79A0-4CC8-9FF1-32B56ACFDE2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C47FEE-2821-4FAA-B2BA-E2149B6E3362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243431-2F62-495A-8946-E3D072F143D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8AF3C5-9306-432A-9D18-8A6B9BFC79BC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7B3297-0A53-47B1-8587-108B4F68E3A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453F67-184B-4B6B-ADD4-30A582A29FA5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A0D70B-48EA-44CC-A5CA-CC37A0BD5C4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42ED44-1C51-4CB4-8E88-3CC6111FD26A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0A46AC-279D-4B4F-9AA5-E2F80C4E4B2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2F4E7B-3AF0-44B9-947E-5637A2028324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B73941-D5AB-418C-865F-1F7B3E1ED77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5E62A3-EF8F-4C96-8704-459323904248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C7186A-F216-4F62-B475-ADE3D84DB4F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B0C1ED-6E45-4DF3-8FBA-98D6E1E8E08B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A4B689-4A51-41B6-AFD6-6F86C87AA1C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8B1A9C-911B-487B-A220-24BC4B05BC70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FFFCCF-7060-47D1-A902-8F8EA444C37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96699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311402"/>
            <a:ext cx="6172200" cy="65375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07DE51FD-F94E-434F-874F-1BBD40094258}" type="datetimeFigureOut">
              <a:rPr lang="ja-JP" altLang="en-US"/>
              <a:pPr>
                <a:defRPr/>
              </a:pPr>
              <a:t>2013/11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993942D0-98AF-483A-9720-BBBAA7FD3BE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0" r:id="rId2"/>
    <p:sldLayoutId id="2147483839" r:id="rId3"/>
    <p:sldLayoutId id="2147483838" r:id="rId4"/>
    <p:sldLayoutId id="2147483837" r:id="rId5"/>
    <p:sldLayoutId id="2147483836" r:id="rId6"/>
    <p:sldLayoutId id="2147483835" r:id="rId7"/>
    <p:sldLayoutId id="2147483834" r:id="rId8"/>
    <p:sldLayoutId id="2147483833" r:id="rId9"/>
    <p:sldLayoutId id="2147483832" r:id="rId10"/>
    <p:sldLayoutId id="214748383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タイトル 1"/>
          <p:cNvSpPr txBox="1">
            <a:spLocks/>
          </p:cNvSpPr>
          <p:nvPr/>
        </p:nvSpPr>
        <p:spPr bwMode="auto">
          <a:xfrm>
            <a:off x="495300" y="660400"/>
            <a:ext cx="19431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5" name="タイトル 1"/>
          <p:cNvSpPr txBox="1">
            <a:spLocks/>
          </p:cNvSpPr>
          <p:nvPr/>
        </p:nvSpPr>
        <p:spPr bwMode="auto">
          <a:xfrm>
            <a:off x="419100" y="6273800"/>
            <a:ext cx="19431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9" name="タイトル 1"/>
          <p:cNvSpPr txBox="1">
            <a:spLocks/>
          </p:cNvSpPr>
          <p:nvPr/>
        </p:nvSpPr>
        <p:spPr bwMode="auto">
          <a:xfrm>
            <a:off x="0" y="-165100"/>
            <a:ext cx="39624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upplementary Figure 2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51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1" y="2321719"/>
            <a:ext cx="2505075" cy="2713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" name="タイトル 1"/>
          <p:cNvSpPr txBox="1">
            <a:spLocks/>
          </p:cNvSpPr>
          <p:nvPr/>
        </p:nvSpPr>
        <p:spPr bwMode="auto">
          <a:xfrm>
            <a:off x="1295401" y="1568450"/>
            <a:ext cx="1100137" cy="742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AF 4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3" name="正方形/長方形 52"/>
          <p:cNvSpPr/>
          <p:nvPr/>
        </p:nvSpPr>
        <p:spPr>
          <a:xfrm>
            <a:off x="1971929" y="2402312"/>
            <a:ext cx="7649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ja-JP" b="1" dirty="0" smtClean="0">
                <a:solidFill>
                  <a:srgbClr val="000000"/>
                </a:solidFill>
                <a:latin typeface="Calibri"/>
              </a:rPr>
              <a:t>37.6%</a:t>
            </a:r>
            <a:endParaRPr lang="en-US" altLang="ja-JP" b="1" dirty="0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5" name="直線矢印コネクタ 54"/>
          <p:cNvCxnSpPr>
            <a:stCxn id="51" idx="3"/>
            <a:endCxn id="60" idx="1"/>
          </p:cNvCxnSpPr>
          <p:nvPr/>
        </p:nvCxnSpPr>
        <p:spPr>
          <a:xfrm flipV="1">
            <a:off x="2962275" y="2127405"/>
            <a:ext cx="780112" cy="155123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矢印コネクタ 55"/>
          <p:cNvCxnSpPr>
            <a:stCxn id="51" idx="3"/>
            <a:endCxn id="65" idx="1"/>
          </p:cNvCxnSpPr>
          <p:nvPr/>
        </p:nvCxnSpPr>
        <p:spPr>
          <a:xfrm>
            <a:off x="2962276" y="3678636"/>
            <a:ext cx="780113" cy="151311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7" name="グループ化 56"/>
          <p:cNvGrpSpPr/>
          <p:nvPr/>
        </p:nvGrpSpPr>
        <p:grpSpPr>
          <a:xfrm>
            <a:off x="3742388" y="247650"/>
            <a:ext cx="2505075" cy="3236670"/>
            <a:chOff x="3245922" y="198887"/>
            <a:chExt cx="2505075" cy="2987695"/>
          </a:xfrm>
        </p:grpSpPr>
        <p:grpSp>
          <p:nvGrpSpPr>
            <p:cNvPr id="58" name="グループ化 57"/>
            <p:cNvGrpSpPr/>
            <p:nvPr/>
          </p:nvGrpSpPr>
          <p:grpSpPr>
            <a:xfrm>
              <a:off x="3245922" y="681507"/>
              <a:ext cx="2505075" cy="2505075"/>
              <a:chOff x="3124200" y="635020"/>
              <a:chExt cx="2505075" cy="2505075"/>
            </a:xfrm>
          </p:grpSpPr>
          <p:pic>
            <p:nvPicPr>
              <p:cNvPr id="60" name="Picture 9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24200" y="635020"/>
                <a:ext cx="2505075" cy="2505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1" name="正方形/長方形 60"/>
              <p:cNvSpPr/>
              <p:nvPr/>
            </p:nvSpPr>
            <p:spPr>
              <a:xfrm>
                <a:off x="4644995" y="715513"/>
                <a:ext cx="764953" cy="3409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ja-JP" b="1" dirty="0" smtClean="0">
                    <a:solidFill>
                      <a:srgbClr val="000000"/>
                    </a:solidFill>
                    <a:latin typeface="Calibri"/>
                  </a:rPr>
                  <a:t>90.8%</a:t>
                </a:r>
                <a:endParaRPr lang="en-US" altLang="ja-JP" b="1" dirty="0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9" name="タイトル 1"/>
            <p:cNvSpPr txBox="1">
              <a:spLocks/>
            </p:cNvSpPr>
            <p:nvPr/>
          </p:nvSpPr>
          <p:spPr bwMode="auto">
            <a:xfrm>
              <a:off x="3694535" y="198887"/>
              <a:ext cx="2023263" cy="685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/>
            <a:lstStyle/>
            <a:p>
              <a:pPr>
                <a:defRPr/>
              </a:pPr>
              <a:r>
                <a:rPr lang="en-US" altLang="ja-JP" sz="2000" b="1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DPN + cells</a:t>
              </a:r>
              <a:endParaRPr lang="ja-JP" altLang="en-US" sz="20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grpSp>
        <p:nvGrpSpPr>
          <p:cNvPr id="62" name="グループ化 61"/>
          <p:cNvGrpSpPr/>
          <p:nvPr/>
        </p:nvGrpSpPr>
        <p:grpSpPr>
          <a:xfrm>
            <a:off x="3742389" y="3307160"/>
            <a:ext cx="2505075" cy="3241502"/>
            <a:chOff x="3245922" y="3535097"/>
            <a:chExt cx="2505075" cy="2992156"/>
          </a:xfrm>
        </p:grpSpPr>
        <p:grpSp>
          <p:nvGrpSpPr>
            <p:cNvPr id="63" name="グループ化 62"/>
            <p:cNvGrpSpPr/>
            <p:nvPr/>
          </p:nvGrpSpPr>
          <p:grpSpPr>
            <a:xfrm>
              <a:off x="3245922" y="4022178"/>
              <a:ext cx="2505075" cy="2505075"/>
              <a:chOff x="3124199" y="3505200"/>
              <a:chExt cx="2505075" cy="2505075"/>
            </a:xfrm>
          </p:grpSpPr>
          <p:pic>
            <p:nvPicPr>
              <p:cNvPr id="65" name="Picture 10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24199" y="3505200"/>
                <a:ext cx="2505075" cy="25050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6" name="正方形/長方形 65"/>
              <p:cNvSpPr/>
              <p:nvPr/>
            </p:nvSpPr>
            <p:spPr>
              <a:xfrm>
                <a:off x="4644994" y="3613666"/>
                <a:ext cx="764953" cy="3409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ja-JP" b="1" dirty="0">
                    <a:solidFill>
                      <a:srgbClr val="000000"/>
                    </a:solidFill>
                    <a:latin typeface="Calibri"/>
                  </a:rPr>
                  <a:t>0.44%</a:t>
                </a:r>
              </a:p>
            </p:txBody>
          </p:sp>
        </p:grpSp>
        <p:sp>
          <p:nvSpPr>
            <p:cNvPr id="64" name="タイトル 1"/>
            <p:cNvSpPr txBox="1">
              <a:spLocks/>
            </p:cNvSpPr>
            <p:nvPr/>
          </p:nvSpPr>
          <p:spPr bwMode="auto">
            <a:xfrm>
              <a:off x="3694534" y="3535097"/>
              <a:ext cx="1981200" cy="685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/>
            <a:lstStyle/>
            <a:p>
              <a:pPr>
                <a:defRPr/>
              </a:pPr>
              <a:r>
                <a:rPr lang="en-US" altLang="ja-JP" sz="2000" b="1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DPN - cells</a:t>
              </a:r>
              <a:endParaRPr lang="ja-JP" altLang="en-US" sz="20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graphicFrame>
        <p:nvGraphicFramePr>
          <p:cNvPr id="72" name="グラフ 7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2403163"/>
              </p:ext>
            </p:extLst>
          </p:nvPr>
        </p:nvGraphicFramePr>
        <p:xfrm>
          <a:off x="1510972" y="6438900"/>
          <a:ext cx="3670628" cy="3467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73" name="グループ化 72"/>
          <p:cNvGrpSpPr/>
          <p:nvPr/>
        </p:nvGrpSpPr>
        <p:grpSpPr>
          <a:xfrm>
            <a:off x="1484487" y="9576000"/>
            <a:ext cx="1511015" cy="284140"/>
            <a:chOff x="-28900" y="3717032"/>
            <a:chExt cx="1511015" cy="262282"/>
          </a:xfrm>
        </p:grpSpPr>
        <p:sp>
          <p:nvSpPr>
            <p:cNvPr id="74" name="テキスト ボックス 73"/>
            <p:cNvSpPr txBox="1"/>
            <p:nvPr/>
          </p:nvSpPr>
          <p:spPr>
            <a:xfrm>
              <a:off x="-28900" y="3723623"/>
              <a:ext cx="611065" cy="2556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/>
                <a:t>PDPN</a:t>
              </a:r>
              <a:endParaRPr kumimoji="1" lang="ja-JP" altLang="en-US" sz="1200" b="1" dirty="0"/>
            </a:p>
          </p:txBody>
        </p:sp>
        <p:sp>
          <p:nvSpPr>
            <p:cNvPr id="75" name="テキスト ボックス 74"/>
            <p:cNvSpPr txBox="1"/>
            <p:nvPr/>
          </p:nvSpPr>
          <p:spPr>
            <a:xfrm>
              <a:off x="539552" y="3723623"/>
              <a:ext cx="511679" cy="2556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/>
                <a:t>high</a:t>
              </a:r>
              <a:endParaRPr kumimoji="1" lang="ja-JP" altLang="en-US" sz="1200" b="1" dirty="0"/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1039365" y="3717032"/>
              <a:ext cx="442750" cy="2556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/>
                <a:t>low</a:t>
              </a:r>
              <a:endParaRPr kumimoji="1" lang="ja-JP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1971957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 bwMode="auto">
        <a:noFill/>
        <a:ln w="9525">
          <a:noFill/>
          <a:miter lim="800000"/>
          <a:headEnd/>
          <a:tailEnd/>
        </a:ln>
      </a:spPr>
      <a:bodyPr wrap="square">
        <a:spAutoFit/>
      </a:bodyPr>
      <a:lstStyle>
        <a:defPPr>
          <a:defRPr sz="2000" dirty="0" smtClean="0">
            <a:latin typeface="+mn-lt"/>
            <a:ea typeface="HGPｺﾞｼｯｸE" pitchFamily="50" charset="-128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51</TotalTime>
  <Words>24</Words>
  <Application>Microsoft Office PowerPoint</Application>
  <PresentationFormat>A4 210 x 297 mm</PresentationFormat>
  <Paragraphs>14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enji FUJIWARA</dc:creator>
  <cp:lastModifiedBy>k-shindo</cp:lastModifiedBy>
  <cp:revision>825</cp:revision>
  <dcterms:created xsi:type="dcterms:W3CDTF">2010-07-20T08:07:54Z</dcterms:created>
  <dcterms:modified xsi:type="dcterms:W3CDTF">2013-11-30T03:12:26Z</dcterms:modified>
</cp:coreProperties>
</file>